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32" d="100"/>
          <a:sy n="32" d="100"/>
        </p:scale>
        <p:origin x="58" y="4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566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7826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9758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973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61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0612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756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909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446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248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1071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8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ctrTitle"/>
          </p:nvPr>
        </p:nvSpPr>
        <p:spPr>
          <a:xfrm>
            <a:off x="1524000" y="1491917"/>
            <a:ext cx="9144000" cy="1142148"/>
          </a:xfrm>
        </p:spPr>
        <p:txBody>
          <a:bodyPr>
            <a:norm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副标题 2"/>
          <p:cNvSpPr>
            <a:spLocks noGrp="1"/>
          </p:cNvSpPr>
          <p:nvPr>
            <p:ph type="subTitle" idx="1"/>
          </p:nvPr>
        </p:nvSpPr>
        <p:spPr>
          <a:xfrm>
            <a:off x="1524000" y="3361407"/>
            <a:ext cx="9144000" cy="652328"/>
          </a:xfrm>
        </p:spPr>
        <p:txBody>
          <a:bodyPr/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agnification images for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159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578543" y="3537359"/>
            <a:ext cx="978529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7.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agnification images for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NLRP3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t 60 d,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22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d o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ge in Figure 3. </a:t>
            </a:r>
            <a:r>
              <a:rPr lang="en-GB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cale bar = </a:t>
            </a:r>
            <a:r>
              <a:rPr lang="en-GB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GB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8908" y="617074"/>
            <a:ext cx="10146901" cy="26782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6779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</TotalTime>
  <Words>31</Words>
  <Application>Microsoft Office PowerPoint</Application>
  <PresentationFormat>宽屏</PresentationFormat>
  <Paragraphs>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Additional file 5 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oyunzh</dc:creator>
  <cp:lastModifiedBy>haoyunzh</cp:lastModifiedBy>
  <cp:revision>17</cp:revision>
  <dcterms:created xsi:type="dcterms:W3CDTF">2022-07-02T10:37:19Z</dcterms:created>
  <dcterms:modified xsi:type="dcterms:W3CDTF">2022-08-01T06:33:37Z</dcterms:modified>
</cp:coreProperties>
</file>